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sldIdLst>
    <p:sldId id="271" r:id="rId2"/>
    <p:sldId id="261" r:id="rId3"/>
    <p:sldId id="264" r:id="rId4"/>
    <p:sldId id="266" r:id="rId5"/>
    <p:sldId id="257" r:id="rId6"/>
    <p:sldId id="258" r:id="rId7"/>
    <p:sldId id="260" r:id="rId8"/>
    <p:sldId id="265" r:id="rId9"/>
    <p:sldId id="269" r:id="rId10"/>
    <p:sldId id="267" r:id="rId11"/>
    <p:sldId id="263" r:id="rId12"/>
    <p:sldId id="259" r:id="rId13"/>
    <p:sldId id="256" r:id="rId14"/>
    <p:sldId id="268" r:id="rId15"/>
    <p:sldId id="270" r:id="rId16"/>
    <p:sldId id="262" r:id="rId1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4" d="100"/>
          <a:sy n="64" d="100"/>
        </p:scale>
        <p:origin x="640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4/2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slideLayout" Target="../slideLayouts/slideLayout1.xml"/><Relationship Id="rId1" Type="http://schemas.openxmlformats.org/officeDocument/2006/relationships/themeOverride" Target="../theme/themeOverride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DDE2CC5-44B6-472B-9D88-974512EC03A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70EAA2F-0210-E4ED-12FD-5C0D04A2FA6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618592" y="78444"/>
            <a:ext cx="9662215" cy="1059793"/>
          </a:xfrm>
        </p:spPr>
        <p:txBody>
          <a:bodyPr>
            <a:normAutofit/>
          </a:bodyPr>
          <a:lstStyle/>
          <a:p>
            <a:r>
              <a:rPr lang="en-US" altLang="zh-CN" sz="4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213B986E-0802-216C-3A65-BC945DB3F5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589" y="1138237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460768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03B6622-FDE2-2CF7-FABD-1FF14C74E36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BD99768-7027-D048-58EE-344B6573B5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618592" y="78444"/>
            <a:ext cx="9662215" cy="1059793"/>
          </a:xfrm>
        </p:spPr>
        <p:txBody>
          <a:bodyPr>
            <a:normAutofit/>
          </a:bodyPr>
          <a:lstStyle/>
          <a:p>
            <a:r>
              <a:rPr lang="en-US" altLang="zh-CN" sz="4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zh-CN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F5C99E54-9DC9-C442-1DB6-352A20C46B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589" y="1224865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765999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>
          <a:extLst>
            <a:ext uri="{FF2B5EF4-FFF2-40B4-BE49-F238E27FC236}">
              <a16:creationId xmlns:a16="http://schemas.microsoft.com/office/drawing/2014/main" id="{E94AF1E2-B9A7-11C7-3E01-CF1C2084397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2715D52-3524-925E-6988-476302AAAF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618592" y="78444"/>
            <a:ext cx="9662215" cy="1059793"/>
          </a:xfrm>
        </p:spPr>
        <p:txBody>
          <a:bodyPr>
            <a:normAutofit/>
          </a:bodyPr>
          <a:lstStyle/>
          <a:p>
            <a:r>
              <a:rPr lang="en-US" altLang="zh-CN" sz="4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endParaRPr lang="zh-CN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E3EA7540-6FD5-092E-35FE-3DFE21A2A57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589" y="1293145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878282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C656EC5-241A-9AB9-FB03-D387DCB25D9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0F25903-00F9-46B7-D165-AC0D6B547F9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618593" y="78444"/>
            <a:ext cx="9144000" cy="1059793"/>
          </a:xfrm>
        </p:spPr>
        <p:txBody>
          <a:bodyPr/>
          <a:lstStyle/>
          <a:p>
            <a:r>
              <a:rPr lang="en-US" altLang="zh-CN" sz="4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endParaRPr lang="zh-CN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1E4DB0AD-AFB4-8A53-75C5-46D3ECAC35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589" y="1138237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764528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ECEE8BD-F4AC-F980-3F8A-C802C34D6CF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618593" y="78444"/>
            <a:ext cx="9144000" cy="1059793"/>
          </a:xfrm>
        </p:spPr>
        <p:txBody>
          <a:bodyPr/>
          <a:lstStyle/>
          <a:p>
            <a:r>
              <a:rPr lang="en-US" altLang="zh-CN" sz="4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68E5060B-6A9A-58F8-03D8-492E52C5A1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4182" y="1293145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642083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9A44C8A-D933-87E8-18AD-58E5441267E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74DF32-A6B1-364A-DA7E-196B612B66B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618592" y="78444"/>
            <a:ext cx="9662215" cy="1059793"/>
          </a:xfrm>
        </p:spPr>
        <p:txBody>
          <a:bodyPr>
            <a:normAutofit/>
          </a:bodyPr>
          <a:lstStyle/>
          <a:p>
            <a:r>
              <a:rPr lang="en-US" altLang="zh-CN" sz="4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endParaRPr lang="zh-CN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CF41B129-BB23-A606-281C-0EC6717D95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589" y="1293145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85164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9FFE834-97A7-43E5-FE14-3EBF06585C1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1A00FCB-859F-C19F-1DDE-A92A516CCC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618592" y="78444"/>
            <a:ext cx="9662215" cy="1059793"/>
          </a:xfrm>
        </p:spPr>
        <p:txBody>
          <a:bodyPr>
            <a:normAutofit/>
          </a:bodyPr>
          <a:lstStyle/>
          <a:p>
            <a:r>
              <a:rPr lang="en-US" altLang="zh-CN" sz="4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endParaRPr lang="zh-CN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29CB95F4-2C93-931C-6302-B855BD04CF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589" y="1138237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337853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D4AB85F-3C33-5440-D144-138BCBAB747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E3B22AE-1C2A-8889-BFA4-458BDB4C4F3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618593" y="78444"/>
            <a:ext cx="9144000" cy="1059793"/>
          </a:xfrm>
        </p:spPr>
        <p:txBody>
          <a:bodyPr/>
          <a:lstStyle/>
          <a:p>
            <a:r>
              <a:rPr lang="en-US" altLang="zh-CN" sz="4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endParaRPr lang="zh-CN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2B12171E-A68A-AD0D-7002-5E15A06841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4182" y="1138237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85823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7D4CC3A-6504-DFA2-E66E-EF5761D8B71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DE5083F-73E9-CD17-390E-FD581E950CD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618593" y="78444"/>
            <a:ext cx="9144000" cy="1059793"/>
          </a:xfrm>
        </p:spPr>
        <p:txBody>
          <a:bodyPr/>
          <a:lstStyle/>
          <a:p>
            <a:r>
              <a:rPr lang="en-US" altLang="zh-CN" sz="4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512952EE-2F48-7824-D3E1-6CC47F23DE4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589" y="1138237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63722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4A2BBEB-1CF7-D18A-875A-4A807AD675D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D1EAFF7-9151-D0B3-AB6C-F29A945712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618592" y="78444"/>
            <a:ext cx="9662215" cy="1059793"/>
          </a:xfrm>
        </p:spPr>
        <p:txBody>
          <a:bodyPr>
            <a:normAutofit/>
          </a:bodyPr>
          <a:lstStyle/>
          <a:p>
            <a:r>
              <a:rPr lang="en-US" altLang="zh-CN" sz="4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AC9580D0-1A18-F547-1330-40FA8633F1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589" y="1293145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52001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40F7143-7D0E-D766-AEE8-6163ABDE4F6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B62671-170F-7089-A74F-F92D6EDC401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618592" y="78444"/>
            <a:ext cx="9662215" cy="1059793"/>
          </a:xfrm>
        </p:spPr>
        <p:txBody>
          <a:bodyPr>
            <a:normAutofit/>
          </a:bodyPr>
          <a:lstStyle/>
          <a:p>
            <a:r>
              <a:rPr lang="en-US" altLang="zh-CN" sz="4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A55A455E-FACC-384B-A561-3138D51833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589" y="1293145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89507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41EA991-4A38-F1DC-90F7-3B1BCDD4FFC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49F022D-289E-F950-2C19-CDD010F98A7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618593" y="78444"/>
            <a:ext cx="9144000" cy="1059793"/>
          </a:xfrm>
        </p:spPr>
        <p:txBody>
          <a:bodyPr/>
          <a:lstStyle/>
          <a:p>
            <a:r>
              <a:rPr lang="en-US" altLang="zh-CN" sz="4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C44C01D7-7244-45DB-25F6-017DE50735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589" y="1371589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75598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8E1AC36-E2E2-2277-804E-CA9A0EC0BE3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2010697-39AD-7893-73E4-E97C0368CDC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618593" y="78444"/>
            <a:ext cx="9144000" cy="1059793"/>
          </a:xfrm>
        </p:spPr>
        <p:txBody>
          <a:bodyPr/>
          <a:lstStyle/>
          <a:p>
            <a:r>
              <a:rPr lang="en-US" altLang="zh-CN" sz="4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B777FB87-114D-EB86-30BC-22ECD71154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4182" y="1138237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09908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DB22543-C13E-A853-7492-74871D49A73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2F38C79-FE0A-B7BD-562B-C3BA63D0910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618593" y="78444"/>
            <a:ext cx="9144000" cy="1059793"/>
          </a:xfrm>
        </p:spPr>
        <p:txBody>
          <a:bodyPr/>
          <a:lstStyle/>
          <a:p>
            <a:r>
              <a:rPr lang="en-US" altLang="zh-CN" sz="4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zh-CN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92CF0F97-B882-D4BE-C80E-BCD8F940C7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589" y="1293145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622754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6084F42-18A9-5EB6-202C-4F6D24F72F4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9F12CAD-C0BE-9CF8-1BFB-E9AC75E25EB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618592" y="78444"/>
            <a:ext cx="9662215" cy="1059793"/>
          </a:xfrm>
        </p:spPr>
        <p:txBody>
          <a:bodyPr>
            <a:normAutofit/>
          </a:bodyPr>
          <a:lstStyle/>
          <a:p>
            <a:r>
              <a:rPr lang="en-US" altLang="zh-CN" sz="4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zh-CN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A0EF3A2A-3ED2-EE95-270B-4C835D3F7E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589" y="1293145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748805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0CC9BDE-971D-C101-9F08-D44A0C67071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74B78C3-6A99-96BB-8EE9-83B49799BB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618592" y="78444"/>
            <a:ext cx="9662215" cy="1059793"/>
          </a:xfrm>
        </p:spPr>
        <p:txBody>
          <a:bodyPr>
            <a:normAutofit/>
          </a:bodyPr>
          <a:lstStyle/>
          <a:p>
            <a:r>
              <a:rPr lang="en-US" altLang="zh-CN" sz="4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zh-CN" altLang="en-US" sz="4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E604C23C-2E44-19CA-8FF7-4E22ED740F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589" y="1138237"/>
            <a:ext cx="10972822" cy="5486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9831481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WPS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874CB"/>
    </a:accent1>
    <a:accent2>
      <a:srgbClr val="EE822F"/>
    </a:accent2>
    <a:accent3>
      <a:srgbClr val="F2BA02"/>
    </a:accent3>
    <a:accent4>
      <a:srgbClr val="75BD42"/>
    </a:accent4>
    <a:accent5>
      <a:srgbClr val="30C0B4"/>
    </a:accent5>
    <a:accent6>
      <a:srgbClr val="E54C5E"/>
    </a:accent6>
    <a:hlink>
      <a:srgbClr val="0026E5"/>
    </a:hlink>
    <a:folHlink>
      <a:srgbClr val="7E1FAD"/>
    </a:folHlink>
  </a:clr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82</TotalTime>
  <Words>16</Words>
  <Application>Microsoft Office PowerPoint</Application>
  <PresentationFormat>宽屏</PresentationFormat>
  <Paragraphs>16</Paragraphs>
  <Slides>1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6</vt:i4>
      </vt:variant>
    </vt:vector>
  </HeadingPairs>
  <TitlesOfParts>
    <vt:vector size="20" baseType="lpstr">
      <vt:lpstr>Arial</vt:lpstr>
      <vt:lpstr>Calibri</vt:lpstr>
      <vt:lpstr>Times New Roman</vt:lpstr>
      <vt:lpstr>WPS</vt:lpstr>
      <vt:lpstr>A</vt:lpstr>
      <vt:lpstr>B</vt:lpstr>
      <vt:lpstr>C</vt:lpstr>
      <vt:lpstr>D</vt:lpstr>
      <vt:lpstr>E</vt:lpstr>
      <vt:lpstr>F</vt:lpstr>
      <vt:lpstr>G</vt:lpstr>
      <vt:lpstr>H</vt:lpstr>
      <vt:lpstr>I</vt:lpstr>
      <vt:lpstr>J</vt:lpstr>
      <vt:lpstr>K</vt:lpstr>
      <vt:lpstr>L</vt:lpstr>
      <vt:lpstr>M</vt:lpstr>
      <vt:lpstr>N</vt:lpstr>
      <vt:lpstr>O</vt:lpstr>
      <vt:lpstr>P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cid</dc:title>
  <dc:creator>zwq</dc:creator>
  <cp:lastModifiedBy>AIR14 2020</cp:lastModifiedBy>
  <cp:revision>7</cp:revision>
  <dcterms:created xsi:type="dcterms:W3CDTF">2023-08-09T12:44:55Z</dcterms:created>
  <dcterms:modified xsi:type="dcterms:W3CDTF">2024-02-28T04:37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B0086CAF875411CACBDA13AB9801EF4_13</vt:lpwstr>
  </property>
  <property fmtid="{D5CDD505-2E9C-101B-9397-08002B2CF9AE}" pid="3" name="KSOProductBuildVer">
    <vt:lpwstr>2052-12.1.0.15259</vt:lpwstr>
  </property>
</Properties>
</file>